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3" r:id="rId2"/>
    <p:sldId id="274" r:id="rId3"/>
    <p:sldId id="275" r:id="rId4"/>
    <p:sldId id="276" r:id="rId5"/>
    <p:sldId id="281" r:id="rId6"/>
    <p:sldId id="278" r:id="rId7"/>
    <p:sldId id="277" r:id="rId8"/>
    <p:sldId id="279" r:id="rId9"/>
    <p:sldId id="282" r:id="rId10"/>
  </p:sldIdLst>
  <p:sldSz cx="12192000" cy="6858000"/>
  <p:notesSz cx="7104063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2B1EAEC-4546-4A88-A651-30A3743A3CED}">
          <p14:sldIdLst/>
        </p14:section>
        <p14:section name="Untitled Section" id="{0D4E471E-545A-4AC5-9999-43C2B1731949}">
          <p14:sldIdLst>
            <p14:sldId id="273"/>
            <p14:sldId id="274"/>
            <p14:sldId id="275"/>
            <p14:sldId id="276"/>
            <p14:sldId id="281"/>
            <p14:sldId id="278"/>
            <p14:sldId id="277"/>
            <p14:sldId id="279"/>
            <p14:sldId id="28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482" userDrawn="1">
          <p15:clr>
            <a:srgbClr val="A4A3A4"/>
          </p15:clr>
        </p15:guide>
        <p15:guide id="2" pos="365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C" initials="R" lastIdx="8" clrIdx="0">
    <p:extLst>
      <p:ext uri="{19B8F6BF-5375-455C-9EA6-DF929625EA0E}">
        <p15:presenceInfo xmlns:p15="http://schemas.microsoft.com/office/powerpoint/2012/main" userId="RAC" providerId="None"/>
      </p:ext>
    </p:extLst>
  </p:cmAuthor>
  <p:cmAuthor id="2" name="IMS" initials="I" lastIdx="3" clrIdx="1">
    <p:extLst>
      <p:ext uri="{19B8F6BF-5375-455C-9EA6-DF929625EA0E}">
        <p15:presenceInfo xmlns:p15="http://schemas.microsoft.com/office/powerpoint/2012/main" userId="IM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FF505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86" autoAdjust="0"/>
    <p:restoredTop sz="94664" autoAdjust="0"/>
  </p:normalViewPr>
  <p:slideViewPr>
    <p:cSldViewPr snapToGrid="0" showGuides="1">
      <p:cViewPr varScale="1">
        <p:scale>
          <a:sx n="68" d="100"/>
          <a:sy n="68" d="100"/>
        </p:scale>
        <p:origin x="776" y="28"/>
      </p:cViewPr>
      <p:guideLst>
        <p:guide orient="horz" pos="482"/>
        <p:guide pos="3659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203" y="0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/>
          <a:lstStyle>
            <a:lvl1pPr algn="r">
              <a:defRPr sz="1200"/>
            </a:lvl1pPr>
          </a:lstStyle>
          <a:p>
            <a:fld id="{38CD6C90-E3DC-4EBB-B26B-09979C3B7C32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81013" y="1277938"/>
            <a:ext cx="614203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98" tIns="47549" rIns="95098" bIns="47549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076" y="4925584"/>
            <a:ext cx="5683914" cy="4030320"/>
          </a:xfrm>
          <a:prstGeom prst="rect">
            <a:avLst/>
          </a:prstGeom>
        </p:spPr>
        <p:txBody>
          <a:bodyPr vert="horz" lIns="95098" tIns="47549" rIns="95098" bIns="4754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721154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203" y="9721154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 anchor="b"/>
          <a:lstStyle>
            <a:lvl1pPr algn="r">
              <a:defRPr sz="1200"/>
            </a:lvl1pPr>
          </a:lstStyle>
          <a:p>
            <a:fld id="{17A7D376-C918-4252-9A4C-884BDF39F1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093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5BCCF-DF06-4102-B7FD-9551EEE6287E}" type="datetime1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3712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2FB94-2F02-4644-B56F-3A265535F25C}" type="datetime1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541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D84EA-EB3B-44D7-8693-E46A1E8B8BA9}" type="datetime1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1394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BFB32-5C4A-4A0F-A781-AF2B61D45190}" type="datetime1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938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131C0-5269-4EDE-9B14-C78A4D15C5E1}" type="datetime1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3001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A16B3-4D10-427E-835F-55E123127819}" type="datetime1">
              <a:rPr lang="en-GB" smtClean="0"/>
              <a:t>0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4569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38F2F-AB6E-4594-8234-3F1A9BC71CA6}" type="datetime1">
              <a:rPr lang="en-GB" smtClean="0"/>
              <a:t>09/04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7210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DB819-BF36-41FD-9626-A79F843D611B}" type="datetime1">
              <a:rPr lang="en-GB" smtClean="0"/>
              <a:t>09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7135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F6DAA-BCE0-44CA-98F9-FE14189B358A}" type="datetime1">
              <a:rPr lang="en-GB" smtClean="0"/>
              <a:t>09/04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1414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6FFD0-2A14-4481-90B8-8F8D944A3AF4}" type="datetime1">
              <a:rPr lang="en-GB" smtClean="0"/>
              <a:t>0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052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8BA36-0C11-4DCC-A94A-A963332BED5C}" type="datetime1">
              <a:rPr lang="en-GB" smtClean="0"/>
              <a:t>0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1711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728DD-0CD6-45E9-9E71-AD0F37356758}" type="datetime1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26547-6FA9-4ADC-8739-A7A57BF85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372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4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microsoft.com/office/2007/relationships/hdphoto" Target="../media/hdphoto2.wdp"/><Relationship Id="rId10" Type="http://schemas.openxmlformats.org/officeDocument/2006/relationships/image" Target="../media/image8.tiff"/><Relationship Id="rId4" Type="http://schemas.openxmlformats.org/officeDocument/2006/relationships/image" Target="../media/image4.png"/><Relationship Id="rId9" Type="http://schemas.openxmlformats.org/officeDocument/2006/relationships/image" Target="../media/image7.tiff"/><Relationship Id="rId14" Type="http://schemas.microsoft.com/office/2007/relationships/hdphoto" Target="../media/hdphoto5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41147" y="2488771"/>
            <a:ext cx="7046108" cy="1420331"/>
          </a:xfrm>
        </p:spPr>
        <p:txBody>
          <a:bodyPr>
            <a:normAutofit/>
          </a:bodyPr>
          <a:lstStyle/>
          <a:p>
            <a:r>
              <a:rPr lang="en-GB" sz="2800" b="1" dirty="0">
                <a:latin typeface="Arial Black" panose="020B0A04020102020204" pitchFamily="34" charset="0"/>
              </a:rPr>
              <a:t>Supplementary data 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93961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2</a:t>
            </a:fld>
            <a:endParaRPr lang="en-GB"/>
          </a:p>
        </p:txBody>
      </p:sp>
      <p:sp>
        <p:nvSpPr>
          <p:cNvPr id="2" name="TextBox 1"/>
          <p:cNvSpPr txBox="1"/>
          <p:nvPr/>
        </p:nvSpPr>
        <p:spPr>
          <a:xfrm>
            <a:off x="1228364" y="5230790"/>
            <a:ext cx="979870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hronic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emia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s associated with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creased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haematological parameters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r RBC synthesis.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blood is collected and plasma is prepared from control (black circles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hronic (dark red squares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nemic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ice. (A) Plasma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haptoglobin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ree haemoglobin,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C) erythropoietin (EPO), (D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oluble transferrin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ceptor (</a:t>
            </a:r>
            <a:r>
              <a:rPr lang="en-GB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fr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(E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) transferrin,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erritin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vels were analysed. The increased serum free haemoglobin, erythropoietin and subsequent decreased </a:t>
            </a:r>
            <a:r>
              <a:rPr lang="en-GB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ptoglobin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levels hint that RBC synthesis is enhanced in CA mice. The Values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re shown as means ± SEM. ***, p≤0.001 n=8 per group. S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dent t-test was used to compare </a:t>
            </a:r>
            <a:r>
              <a:rPr lang="en-GB" sz="14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etween two groups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3271958"/>
              </p:ext>
            </p:extLst>
          </p:nvPr>
        </p:nvGraphicFramePr>
        <p:xfrm>
          <a:off x="2414925" y="0"/>
          <a:ext cx="6195675" cy="52175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30" name="Prism 8" r:id="rId3" imgW="8703346" imgH="7854068" progId="Prism8.Document">
                  <p:embed/>
                </p:oleObj>
              </mc:Choice>
              <mc:Fallback>
                <p:oleObj name="Prism 8" r:id="rId3" imgW="8703346" imgH="7854068" progId="Prism8.Document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14925" y="0"/>
                        <a:ext cx="6195675" cy="52175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2391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37595"/>
            <a:ext cx="2743200" cy="365125"/>
          </a:xfrm>
        </p:spPr>
        <p:txBody>
          <a:bodyPr/>
          <a:lstStyle/>
          <a:p>
            <a:fld id="{9E926547-6FA9-4ADC-8739-A7A57BF850F6}" type="slidenum">
              <a:rPr lang="en-GB" smtClean="0"/>
              <a:t>3</a:t>
            </a:fld>
            <a:endParaRPr lang="en-GB"/>
          </a:p>
        </p:txBody>
      </p:sp>
      <p:graphicFrame>
        <p:nvGraphicFramePr>
          <p:cNvPr id="5" name="Objek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5765328"/>
              </p:ext>
            </p:extLst>
          </p:nvPr>
        </p:nvGraphicFramePr>
        <p:xfrm>
          <a:off x="3540598" y="397513"/>
          <a:ext cx="4031304" cy="47436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452" name="Prism 8" r:id="rId3" imgW="5870268" imgH="6907504" progId="Prism8.Document">
                  <p:embed/>
                </p:oleObj>
              </mc:Choice>
              <mc:Fallback>
                <p:oleObj name="Prism 8" r:id="rId3" imgW="5870268" imgH="6907504" progId="Prism8.Document">
                  <p:embed/>
                  <p:pic>
                    <p:nvPicPr>
                      <p:cNvPr id="5" name="Objekt 3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40598" y="397513"/>
                        <a:ext cx="4031304" cy="474360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80429" y="5410058"/>
            <a:ext cx="1034103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hronic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emia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s associated with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creased inflammation.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blood is collected and plasma is prepared from basal, 1 week, 3 week, and 5 weeks after anemia induction. (A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nterferon gamma (IFN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γ)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(B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umour Necrosis Factor alpha (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, (C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nterleukin 10 (IL-10)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(D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nterleukin-1</a:t>
            </a:r>
            <a:r>
              <a:rPr lang="el-G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IL-1</a:t>
            </a:r>
            <a:r>
              <a:rPr lang="el-G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, (E)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Interleukin 6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L-6), (F)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nterleukin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7A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L-17A)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ere analysed using multiplex assay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Values are shown as means ± SEM.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,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≤0.05; **, p≤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;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***, p≤0.001 .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n=8 per group. One-Way ANOVA and </a:t>
            </a:r>
            <a:r>
              <a:rPr lang="en-GB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nferroni’s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ost-hoc test was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sed compare 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 and respective </a:t>
            </a:r>
            <a:r>
              <a:rPr lang="en-GB" sz="14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ek values.</a:t>
            </a:r>
            <a:endParaRPr lang="en-GB" sz="14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4748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4</a:t>
            </a:fld>
            <a:endParaRPr lang="en-GB"/>
          </a:p>
        </p:txBody>
      </p:sp>
      <p:pic>
        <p:nvPicPr>
          <p:cNvPr id="5" name="Grafik 3" descr="Ein Bild, das Dunkel, Nachthimmel enthält.&#10;&#10;Automatisch generierte Beschreibung">
            <a:extLst>
              <a:ext uri="{FF2B5EF4-FFF2-40B4-BE49-F238E27FC236}">
                <a16:creationId xmlns:a16="http://schemas.microsoft.com/office/drawing/2014/main" id="{C17AFD56-3075-7DC8-21D5-27414AFB48D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 contrast="4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742251" y="2561444"/>
            <a:ext cx="1704214" cy="1963395"/>
          </a:xfrm>
          <a:prstGeom prst="rect">
            <a:avLst/>
          </a:prstGeom>
        </p:spPr>
      </p:pic>
      <p:pic>
        <p:nvPicPr>
          <p:cNvPr id="6" name="Grafik 4" descr="Ein Bild, das Dunkel, Nachthimmel enthält.&#10;&#10;Automatisch generierte Beschreibung">
            <a:extLst>
              <a:ext uri="{FF2B5EF4-FFF2-40B4-BE49-F238E27FC236}">
                <a16:creationId xmlns:a16="http://schemas.microsoft.com/office/drawing/2014/main" id="{D26EAB67-E4DE-B21E-472D-8E357BD33A9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5000" contras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738646" y="573295"/>
            <a:ext cx="1704215" cy="196339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336357" y="340083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82054" y="342135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418571" y="340083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MPO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492116" y="345550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32115" y="3371536"/>
            <a:ext cx="17235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anemi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056725" y="1445867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uppieren 2"/>
          <p:cNvGrpSpPr/>
          <p:nvPr/>
        </p:nvGrpSpPr>
        <p:grpSpPr>
          <a:xfrm>
            <a:off x="3697282" y="2679038"/>
            <a:ext cx="1969344" cy="1723550"/>
            <a:chOff x="3661753" y="1167801"/>
            <a:chExt cx="1966498" cy="1704215"/>
          </a:xfrm>
        </p:grpSpPr>
        <p:pic>
          <p:nvPicPr>
            <p:cNvPr id="14" name="Grafik 5" descr="Ein Bild, das Licht enthält.&#10;&#10;Automatisch generierte Beschreibung">
              <a:extLst>
                <a:ext uri="{FF2B5EF4-FFF2-40B4-BE49-F238E27FC236}">
                  <a16:creationId xmlns:a16="http://schemas.microsoft.com/office/drawing/2014/main" id="{8047DFFE-B854-82FD-BB4E-6264DFB614A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3792894" y="1036660"/>
              <a:ext cx="1704215" cy="1966498"/>
            </a:xfrm>
            <a:prstGeom prst="rect">
              <a:avLst/>
            </a:prstGeom>
          </p:spPr>
        </p:pic>
        <p:sp>
          <p:nvSpPr>
            <p:cNvPr id="15" name="Isosceles Triangle 14"/>
            <p:cNvSpPr/>
            <p:nvPr/>
          </p:nvSpPr>
          <p:spPr>
            <a:xfrm rot="12452821">
              <a:off x="4880377" y="1751669"/>
              <a:ext cx="134673" cy="184750"/>
            </a:xfrm>
            <a:prstGeom prst="triangle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6" name="Gruppieren 28"/>
          <p:cNvGrpSpPr/>
          <p:nvPr/>
        </p:nvGrpSpPr>
        <p:grpSpPr>
          <a:xfrm>
            <a:off x="5796132" y="2671699"/>
            <a:ext cx="1966497" cy="1723550"/>
            <a:chOff x="5787878" y="1167802"/>
            <a:chExt cx="1966497" cy="1704214"/>
          </a:xfrm>
        </p:grpSpPr>
        <p:pic>
          <p:nvPicPr>
            <p:cNvPr id="17" name="Grafik 7" descr="Ein Bild, das Licht, Dunkel, Verschwommen enthält.&#10;&#10;Automatisch generierte Beschreibung">
              <a:extLst>
                <a:ext uri="{FF2B5EF4-FFF2-40B4-BE49-F238E27FC236}">
                  <a16:creationId xmlns:a16="http://schemas.microsoft.com/office/drawing/2014/main" id="{B0DF54D9-6D0E-B5FE-EB43-5E98B8C972B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5919020" y="1036660"/>
              <a:ext cx="1704214" cy="1966497"/>
            </a:xfrm>
            <a:prstGeom prst="rect">
              <a:avLst/>
            </a:prstGeom>
          </p:spPr>
        </p:pic>
        <p:sp>
          <p:nvSpPr>
            <p:cNvPr id="18" name="Isosceles Triangle 17"/>
            <p:cNvSpPr/>
            <p:nvPr/>
          </p:nvSpPr>
          <p:spPr>
            <a:xfrm rot="12452821">
              <a:off x="7022321" y="1751670"/>
              <a:ext cx="134673" cy="18475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9" name="Gruppieren 1"/>
          <p:cNvGrpSpPr/>
          <p:nvPr/>
        </p:nvGrpSpPr>
        <p:grpSpPr>
          <a:xfrm>
            <a:off x="3697281" y="711326"/>
            <a:ext cx="1963398" cy="1704217"/>
            <a:chOff x="3661752" y="3166799"/>
            <a:chExt cx="1961800" cy="1738576"/>
          </a:xfrm>
        </p:grpSpPr>
        <p:pic>
          <p:nvPicPr>
            <p:cNvPr id="20" name="Grafik 8" descr="Ein Bild, das Dunkel, Licht enthält.&#10;&#10;Automatisch generierte Beschreibung">
              <a:extLst>
                <a:ext uri="{FF2B5EF4-FFF2-40B4-BE49-F238E27FC236}">
                  <a16:creationId xmlns:a16="http://schemas.microsoft.com/office/drawing/2014/main" id="{6DAB3F25-457F-A47C-8A65-BCAD9DCD7C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711" b="4005"/>
            <a:stretch/>
          </p:blipFill>
          <p:spPr>
            <a:xfrm rot="16200000">
              <a:off x="3773364" y="3055187"/>
              <a:ext cx="1738576" cy="1961800"/>
            </a:xfrm>
            <a:prstGeom prst="rect">
              <a:avLst/>
            </a:prstGeom>
          </p:spPr>
        </p:pic>
        <p:sp>
          <p:nvSpPr>
            <p:cNvPr id="21" name="Isosceles Triangle 20"/>
            <p:cNvSpPr/>
            <p:nvPr/>
          </p:nvSpPr>
          <p:spPr>
            <a:xfrm rot="12452821">
              <a:off x="4624423" y="3845424"/>
              <a:ext cx="134673" cy="184750"/>
            </a:xfrm>
            <a:prstGeom prst="triangle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2" name="Gruppieren 29"/>
          <p:cNvGrpSpPr/>
          <p:nvPr/>
        </p:nvGrpSpPr>
        <p:grpSpPr>
          <a:xfrm>
            <a:off x="5792789" y="711326"/>
            <a:ext cx="1966869" cy="1704218"/>
            <a:chOff x="5790984" y="3170719"/>
            <a:chExt cx="1963392" cy="1734656"/>
          </a:xfrm>
        </p:grpSpPr>
        <p:pic>
          <p:nvPicPr>
            <p:cNvPr id="23" name="Grafik 11" descr="Ein Bild, das Dunkel, Nacht, Stern enthält.&#10;&#10;Automatisch generierte Beschreibung">
              <a:extLst>
                <a:ext uri="{FF2B5EF4-FFF2-40B4-BE49-F238E27FC236}">
                  <a16:creationId xmlns:a16="http://schemas.microsoft.com/office/drawing/2014/main" id="{50E54D84-A06C-546B-4230-856EA47F4A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5905352" y="3056351"/>
              <a:ext cx="1734656" cy="1963392"/>
            </a:xfrm>
            <a:prstGeom prst="rect">
              <a:avLst/>
            </a:prstGeom>
          </p:spPr>
        </p:pic>
        <p:sp>
          <p:nvSpPr>
            <p:cNvPr id="24" name="Isosceles Triangle 23"/>
            <p:cNvSpPr/>
            <p:nvPr/>
          </p:nvSpPr>
          <p:spPr>
            <a:xfrm rot="12452821">
              <a:off x="6817472" y="3845425"/>
              <a:ext cx="134673" cy="18475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5" name="Gruppieren 35"/>
          <p:cNvGrpSpPr/>
          <p:nvPr/>
        </p:nvGrpSpPr>
        <p:grpSpPr>
          <a:xfrm>
            <a:off x="7891768" y="711326"/>
            <a:ext cx="1936279" cy="1704218"/>
            <a:chOff x="7919160" y="3430581"/>
            <a:chExt cx="1992592" cy="1746274"/>
          </a:xfrm>
        </p:grpSpPr>
        <p:pic>
          <p:nvPicPr>
            <p:cNvPr id="26" name="Grafik 13" descr="Ein Bild, das Wirbellose, Wurm, Dunkel, Licht enthält.&#10;&#10;Automatisch generierte Beschreibung">
              <a:extLst>
                <a:ext uri="{FF2B5EF4-FFF2-40B4-BE49-F238E27FC236}">
                  <a16:creationId xmlns:a16="http://schemas.microsoft.com/office/drawing/2014/main" id="{3BE5829D-7878-EF94-89AD-25277B82E0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284" b="2499"/>
            <a:stretch/>
          </p:blipFill>
          <p:spPr>
            <a:xfrm rot="16200000">
              <a:off x="8042319" y="3307422"/>
              <a:ext cx="1746274" cy="1992592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9387981" y="4207731"/>
              <a:ext cx="33855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dirty="0">
                  <a:solidFill>
                    <a:schemeClr val="bg1"/>
                  </a:solidFill>
                </a:rPr>
                <a:t>*</a:t>
              </a:r>
              <a:endParaRPr lang="en-GB" sz="2400" dirty="0">
                <a:solidFill>
                  <a:schemeClr val="bg1"/>
                </a:solidFill>
              </a:endParaRPr>
            </a:p>
          </p:txBody>
        </p:sp>
        <p:sp>
          <p:nvSpPr>
            <p:cNvPr id="28" name="Isosceles Triangle 27"/>
            <p:cNvSpPr/>
            <p:nvPr/>
          </p:nvSpPr>
          <p:spPr>
            <a:xfrm rot="12452821">
              <a:off x="8869278" y="4113227"/>
              <a:ext cx="123373" cy="160695"/>
            </a:xfrm>
            <a:prstGeom prst="triangle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9" name="Gruppieren 36"/>
          <p:cNvGrpSpPr/>
          <p:nvPr/>
        </p:nvGrpSpPr>
        <p:grpSpPr>
          <a:xfrm>
            <a:off x="7892138" y="2671698"/>
            <a:ext cx="1966498" cy="1730890"/>
            <a:chOff x="7942311" y="3178146"/>
            <a:chExt cx="2030897" cy="1687919"/>
          </a:xfrm>
        </p:grpSpPr>
        <p:grpSp>
          <p:nvGrpSpPr>
            <p:cNvPr id="30" name="Gruppieren 33"/>
            <p:cNvGrpSpPr/>
            <p:nvPr/>
          </p:nvGrpSpPr>
          <p:grpSpPr>
            <a:xfrm>
              <a:off x="7942311" y="3178146"/>
              <a:ext cx="2030897" cy="1687919"/>
              <a:chOff x="7937328" y="1173268"/>
              <a:chExt cx="2030897" cy="1687919"/>
            </a:xfrm>
          </p:grpSpPr>
          <p:grpSp>
            <p:nvGrpSpPr>
              <p:cNvPr id="32" name="Gruppieren 31"/>
              <p:cNvGrpSpPr/>
              <p:nvPr/>
            </p:nvGrpSpPr>
            <p:grpSpPr>
              <a:xfrm>
                <a:off x="7937328" y="1173268"/>
                <a:ext cx="1999306" cy="1687919"/>
                <a:chOff x="7937328" y="1173268"/>
                <a:chExt cx="1999306" cy="1687919"/>
              </a:xfrm>
            </p:grpSpPr>
            <p:pic>
              <p:nvPicPr>
                <p:cNvPr id="34" name="Grafik 9">
                  <a:extLst>
                    <a:ext uri="{FF2B5EF4-FFF2-40B4-BE49-F238E27FC236}">
                      <a16:creationId xmlns:a16="http://schemas.microsoft.com/office/drawing/2014/main" id="{355B443F-B7E8-A806-F8E7-DE73081E7F3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1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82"/>
                <a:stretch/>
              </p:blipFill>
              <p:spPr>
                <a:xfrm rot="16200000">
                  <a:off x="8093021" y="1017575"/>
                  <a:ext cx="1687919" cy="1999306"/>
                </a:xfrm>
                <a:prstGeom prst="rect">
                  <a:avLst/>
                </a:prstGeom>
              </p:spPr>
            </p:pic>
            <p:sp>
              <p:nvSpPr>
                <p:cNvPr id="35" name="Isosceles Triangle 34"/>
                <p:cNvSpPr/>
                <p:nvPr/>
              </p:nvSpPr>
              <p:spPr>
                <a:xfrm rot="12452821">
                  <a:off x="9225472" y="1767480"/>
                  <a:ext cx="123373" cy="160695"/>
                </a:xfrm>
                <a:prstGeom prst="triangle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9457054" y="2006180"/>
                  <a:ext cx="33855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2400" dirty="0">
                      <a:solidFill>
                        <a:schemeClr val="bg1"/>
                      </a:solidFill>
                    </a:rPr>
                    <a:t>*</a:t>
                  </a:r>
                  <a:endParaRPr lang="en-GB" sz="24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33" name="TextBox 32"/>
              <p:cNvSpPr txBox="1"/>
              <p:nvPr/>
            </p:nvSpPr>
            <p:spPr>
              <a:xfrm>
                <a:off x="9381205" y="2522385"/>
                <a:ext cx="58702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DE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</a:t>
                </a:r>
                <a:r>
                  <a:rPr lang="de-DE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en-GB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1" name="Straight Connector 30"/>
            <p:cNvCxnSpPr/>
            <p:nvPr/>
          </p:nvCxnSpPr>
          <p:spPr>
            <a:xfrm>
              <a:off x="9441807" y="4785434"/>
              <a:ext cx="468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TextBox 36"/>
          <p:cNvSpPr txBox="1"/>
          <p:nvPr/>
        </p:nvSpPr>
        <p:spPr>
          <a:xfrm>
            <a:off x="1009096" y="4584648"/>
            <a:ext cx="9937072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GB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Expression of MPO in endothelium is increased in chronic anemic mice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horacic aortas isolated from sham and chronic anemic mice. Representative immunohistochemistry images of aortic sections stained with endothelial cell marker CD-31 (anti-CD31), and also for MPO (anti- MPO). DAPI (blue) staining is used to detect the nucleus. Arrowheads are in the luminal side pointing towards the respective staining. Results are representative pictures of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sham) and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chronic anemic) independent experiments. Adventitial layer showed some unspecific staining in both groups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6427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5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220394" y="4795867"/>
            <a:ext cx="11470723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RBCs from anemic mice induce endothelial dysfunction in murine WT mice aortic rings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BCs were isolated from chronic anemic mice (red squares) and sham mice (black circles). Haematocrit (40%) was prepared in a KREBS buffer. Aortic rings were incubated with haematocrit for 2 (A-C) or 6 (D-F) hours at 37°C, mounted in a wire-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yograph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and pre-contracted with phenylephrine (10 µM, A). (B, E) Relaxation responses to acetylcholine (1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-10 µM) in the presence of indomethacin (10 µM, COX inhibitor). (C, F) Relaxation responses to acetylcholine in the presence of L-NAME (100 µM, NOS inhibitor) and indomethacin. (D, G) Endothelium-independent relaxation responses to SNP (10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-10 µM, NO donor). Values are shown as means ± SEM. *, p≤0.05. CRCs were analysed by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wo-Way ANOVA an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’s post-hoc test to compare sham and chronic anemic groups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Mann–Whitney test was used to compare the maximum contraction (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4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) responses. N=4-8 per group. Some of the anemic RBCs incubated aortic rings did not constrict to phenylephrine so we excluded them from experiments.</a:t>
            </a:r>
          </a:p>
          <a:p>
            <a:pPr algn="just"/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4"/>
          <p:cNvSpPr>
            <a:spLocks noChangeArrowheads="1"/>
          </p:cNvSpPr>
          <p:nvPr/>
        </p:nvSpPr>
        <p:spPr bwMode="auto">
          <a:xfrm>
            <a:off x="2232074" y="12192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5693612"/>
              </p:ext>
            </p:extLst>
          </p:nvPr>
        </p:nvGraphicFramePr>
        <p:xfrm>
          <a:off x="2232074" y="-76254"/>
          <a:ext cx="6231988" cy="49693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50" name="Prism 8" r:id="rId3" imgW="9047491" imgH="7236947" progId="Prism8.Document">
                  <p:embed/>
                </p:oleObj>
              </mc:Choice>
              <mc:Fallback>
                <p:oleObj name="Prism 8" r:id="rId3" imgW="9047491" imgH="7236947" progId="Prism8.Document">
                  <p:embed/>
                  <p:pic>
                    <p:nvPicPr>
                      <p:cNvPr id="0" name="Object 4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32074" y="-76254"/>
                        <a:ext cx="6231988" cy="496934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84854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6</a:t>
            </a:fld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4778" y="459624"/>
            <a:ext cx="5499566" cy="471687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1739" y="421902"/>
            <a:ext cx="6011338" cy="479231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312025" y="5600618"/>
            <a:ext cx="100417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 pictures (uncut) of eNOS, iNOS, 3-Nitrotyrosine and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yeloproxidase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3667504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7</a:t>
            </a:fld>
            <a:endParaRPr lang="en-GB"/>
          </a:p>
        </p:txBody>
      </p:sp>
      <p:sp>
        <p:nvSpPr>
          <p:cNvPr id="6" name="Rectangle 5"/>
          <p:cNvSpPr/>
          <p:nvPr/>
        </p:nvSpPr>
        <p:spPr>
          <a:xfrm>
            <a:off x="1059766" y="5657671"/>
            <a:ext cx="1012085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.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llustration of  acute and chronic blood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loss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emia effects on vascular function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he comparison is performed based on present study results and previously published data (Ref 19). In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trary to acute anemia, chronic anemia is associated with progressive loss of FMD responses.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↑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increased;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↓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decrease;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↔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unchanged; -: not known.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hibition of ROS or myeloperoxidase improved the endothelial dysfunction in CA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6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7021" y="99753"/>
            <a:ext cx="7332133" cy="51324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0985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8</a:t>
            </a:fld>
            <a:endParaRPr lang="en-GB"/>
          </a:p>
        </p:txBody>
      </p:sp>
      <p:sp>
        <p:nvSpPr>
          <p:cNvPr id="8" name="TextBox 7"/>
          <p:cNvSpPr txBox="1"/>
          <p:nvPr/>
        </p:nvSpPr>
        <p:spPr>
          <a:xfrm>
            <a:off x="1315368" y="724492"/>
            <a:ext cx="101969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Table S1. Patient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haracteristics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hronic Coronary Syndrome patients (CCS) with anemia and without anemia.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67605" y="5600517"/>
            <a:ext cx="79015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he above patient samples were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to perform experiments mentioned in the main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A-C.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QR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: Interquartile range; GFR: Glomerular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ltration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e; NA: Not applicable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4511085"/>
              </p:ext>
            </p:extLst>
          </p:nvPr>
        </p:nvGraphicFramePr>
        <p:xfrm>
          <a:off x="1502229" y="1738569"/>
          <a:ext cx="9323976" cy="3235960"/>
        </p:xfrm>
        <a:graphic>
          <a:graphicData uri="http://schemas.openxmlformats.org/drawingml/2006/table">
            <a:tbl>
              <a:tblPr bandRow="1">
                <a:tableStyleId>{D7AC3CCA-C797-4891-BE02-D94E43425B78}</a:tableStyleId>
              </a:tblPr>
              <a:tblGrid>
                <a:gridCol w="3683725">
                  <a:extLst>
                    <a:ext uri="{9D8B030D-6E8A-4147-A177-3AD203B41FA5}">
                      <a16:colId xmlns:a16="http://schemas.microsoft.com/office/drawing/2014/main" val="2127766096"/>
                    </a:ext>
                  </a:extLst>
                </a:gridCol>
                <a:gridCol w="2011680">
                  <a:extLst>
                    <a:ext uri="{9D8B030D-6E8A-4147-A177-3AD203B41FA5}">
                      <a16:colId xmlns:a16="http://schemas.microsoft.com/office/drawing/2014/main" val="4134126007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520291758"/>
                    </a:ext>
                  </a:extLst>
                </a:gridCol>
                <a:gridCol w="1525451">
                  <a:extLst>
                    <a:ext uri="{9D8B030D-6E8A-4147-A177-3AD203B41FA5}">
                      <a16:colId xmlns:a16="http://schemas.microsoft.com/office/drawing/2014/main" val="314622228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b="1" dirty="0"/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b="1" dirty="0" smtClean="0"/>
                        <a:t>No anemia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b="1" dirty="0" smtClean="0"/>
                        <a:t>(n=11)</a:t>
                      </a:r>
                      <a:endParaRPr lang="en-GB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b="1" dirty="0" smtClean="0"/>
                        <a:t>Anemia</a:t>
                      </a:r>
                      <a:r>
                        <a:rPr lang="en-GB" b="1" baseline="0" dirty="0" smtClean="0"/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b="1" dirty="0" smtClean="0"/>
                        <a:t>(n=11)</a:t>
                      </a:r>
                      <a:endParaRPr lang="en-GB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b="1" dirty="0" smtClean="0"/>
                        <a:t>P-</a:t>
                      </a:r>
                      <a:r>
                        <a:rPr lang="de-DE" b="1" dirty="0" err="1" smtClean="0"/>
                        <a:t>value</a:t>
                      </a:r>
                      <a:endParaRPr lang="en-GB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55825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Age, years, median</a:t>
                      </a:r>
                      <a:r>
                        <a:rPr lang="en-GB" b="1" baseline="0" dirty="0" smtClean="0">
                          <a:solidFill>
                            <a:schemeClr val="tx1"/>
                          </a:solidFill>
                        </a:rPr>
                        <a:t> (IQR)</a:t>
                      </a:r>
                      <a:endParaRPr lang="en-GB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74 (65-77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76 (</a:t>
                      </a:r>
                      <a:r>
                        <a:rPr lang="en-GB" b="1" baseline="0" dirty="0" smtClean="0">
                          <a:solidFill>
                            <a:schemeClr val="tx1"/>
                          </a:solidFill>
                        </a:rPr>
                        <a:t>53</a:t>
                      </a:r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-80)</a:t>
                      </a:r>
                      <a:endParaRPr lang="en-GB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b="1" dirty="0" smtClean="0">
                          <a:solidFill>
                            <a:schemeClr val="tx1"/>
                          </a:solidFill>
                        </a:rPr>
                        <a:t>0.881</a:t>
                      </a:r>
                      <a:endParaRPr lang="en-GB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32790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x, n 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9 (82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en-GB" sz="1600" b="1" dirty="0" smtClean="0">
                          <a:solidFill>
                            <a:schemeClr val="tx1"/>
                          </a:solidFill>
                        </a:rPr>
                        <a:t>(</a:t>
                      </a:r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r>
                        <a:rPr lang="en-GB" sz="1600" b="1" dirty="0" smtClean="0">
                          <a:solidFill>
                            <a:schemeClr val="tx1"/>
                          </a:solidFill>
                        </a:rPr>
                        <a:t>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9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86743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, n 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9 (82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45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6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8665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 mellitus, n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4926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6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e</a:t>
                      </a:r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600" b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oking</a:t>
                      </a:r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 (18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2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77127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R,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l</a:t>
                      </a:r>
                      <a:r>
                        <a:rPr lang="de-DE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in/1.73m</a:t>
                      </a:r>
                      <a:r>
                        <a:rPr lang="de-DE" sz="16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edian (IQR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5 (54-90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 (58-10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2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81984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6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</a:t>
                      </a:r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g/dl, median (IQR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4.3 (13.4-15.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0</a:t>
                      </a:r>
                      <a:r>
                        <a:rPr lang="de-DE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8.0-12.0)</a:t>
                      </a:r>
                      <a:endParaRPr lang="de-DE" sz="16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93833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60309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26547-6FA9-4ADC-8739-A7A57BF850F6}" type="slidenum">
              <a:rPr lang="en-GB" smtClean="0"/>
              <a:t>9</a:t>
            </a:fld>
            <a:endParaRPr lang="en-GB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2563085"/>
              </p:ext>
            </p:extLst>
          </p:nvPr>
        </p:nvGraphicFramePr>
        <p:xfrm>
          <a:off x="1276252" y="1658615"/>
          <a:ext cx="9323976" cy="3235960"/>
        </p:xfrm>
        <a:graphic>
          <a:graphicData uri="http://schemas.openxmlformats.org/drawingml/2006/table">
            <a:tbl>
              <a:tblPr bandRow="1">
                <a:tableStyleId>{D7AC3CCA-C797-4891-BE02-D94E43425B78}</a:tableStyleId>
              </a:tblPr>
              <a:tblGrid>
                <a:gridCol w="3683725">
                  <a:extLst>
                    <a:ext uri="{9D8B030D-6E8A-4147-A177-3AD203B41FA5}">
                      <a16:colId xmlns:a16="http://schemas.microsoft.com/office/drawing/2014/main" val="2127766096"/>
                    </a:ext>
                  </a:extLst>
                </a:gridCol>
                <a:gridCol w="2011680">
                  <a:extLst>
                    <a:ext uri="{9D8B030D-6E8A-4147-A177-3AD203B41FA5}">
                      <a16:colId xmlns:a16="http://schemas.microsoft.com/office/drawing/2014/main" val="4134126007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520291758"/>
                    </a:ext>
                  </a:extLst>
                </a:gridCol>
                <a:gridCol w="1525451">
                  <a:extLst>
                    <a:ext uri="{9D8B030D-6E8A-4147-A177-3AD203B41FA5}">
                      <a16:colId xmlns:a16="http://schemas.microsoft.com/office/drawing/2014/main" val="314622228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b="1" dirty="0"/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b="1" dirty="0" smtClean="0"/>
                        <a:t>No anemia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b="1" dirty="0" smtClean="0"/>
                        <a:t>(n=30)</a:t>
                      </a:r>
                      <a:endParaRPr lang="en-GB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b="1" dirty="0" smtClean="0"/>
                        <a:t>Anemia</a:t>
                      </a:r>
                      <a:r>
                        <a:rPr lang="en-GB" b="1" baseline="0" dirty="0" smtClean="0"/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b="1" dirty="0" smtClean="0"/>
                        <a:t>(n=30)</a:t>
                      </a:r>
                      <a:endParaRPr lang="en-GB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b="1" dirty="0" smtClean="0"/>
                        <a:t>P-</a:t>
                      </a:r>
                      <a:r>
                        <a:rPr lang="de-DE" b="1" dirty="0" err="1" smtClean="0"/>
                        <a:t>value</a:t>
                      </a:r>
                      <a:endParaRPr lang="en-GB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55825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Age, years, median</a:t>
                      </a:r>
                      <a:r>
                        <a:rPr lang="en-GB" b="1" baseline="0" dirty="0" smtClean="0">
                          <a:solidFill>
                            <a:schemeClr val="tx1"/>
                          </a:solidFill>
                        </a:rPr>
                        <a:t> (IQR)</a:t>
                      </a:r>
                      <a:endParaRPr lang="en-GB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76 (69-84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80 (</a:t>
                      </a:r>
                      <a:r>
                        <a:rPr lang="en-GB" b="1" baseline="0" dirty="0" smtClean="0">
                          <a:solidFill>
                            <a:schemeClr val="tx1"/>
                          </a:solidFill>
                        </a:rPr>
                        <a:t>76</a:t>
                      </a:r>
                      <a:r>
                        <a:rPr lang="en-GB" b="1" dirty="0" smtClean="0">
                          <a:solidFill>
                            <a:schemeClr val="tx1"/>
                          </a:solidFill>
                        </a:rPr>
                        <a:t>-85)</a:t>
                      </a:r>
                      <a:endParaRPr lang="en-GB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b="1" dirty="0" smtClean="0">
                          <a:solidFill>
                            <a:schemeClr val="tx1"/>
                          </a:solidFill>
                        </a:rPr>
                        <a:t>0.043</a:t>
                      </a:r>
                      <a:endParaRPr lang="en-GB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32790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x, n 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8 (60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GB" sz="1600" b="1" dirty="0" smtClean="0">
                          <a:solidFill>
                            <a:schemeClr val="tx1"/>
                          </a:solidFill>
                        </a:rPr>
                        <a:t>(</a:t>
                      </a:r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6</a:t>
                      </a:r>
                      <a:r>
                        <a:rPr lang="en-GB" sz="1600" b="1" dirty="0" smtClean="0">
                          <a:solidFill>
                            <a:schemeClr val="tx1"/>
                          </a:solidFill>
                        </a:rPr>
                        <a:t>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9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86743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, n 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7 (56.6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73.3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8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8665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 mellitus, n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4926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6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e</a:t>
                      </a:r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600" b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oking</a:t>
                      </a:r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 (10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33.3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2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77127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R,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l</a:t>
                      </a:r>
                      <a:r>
                        <a:rPr lang="de-DE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in/1.73m</a:t>
                      </a:r>
                      <a:r>
                        <a:rPr lang="de-DE" sz="16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GB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edian (IQR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0.5 (51-78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 (56-85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3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81984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6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</a:t>
                      </a:r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g/dl, median (IQR)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 (13.2-14.4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 (9.1-10.7)</a:t>
                      </a:r>
                      <a:endParaRPr lang="de-DE" sz="16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6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  <a:endParaRPr lang="en-GB" sz="1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9383384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127292" y="681681"/>
            <a:ext cx="1030026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2. Patient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nic Coronary Syndrome patients (CCS) with anemia and without anemia.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27292" y="5319464"/>
            <a:ext cx="97016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above patient samples were used to perform experiments mentioned in the main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gures 5B, 5D, 7D, and Figure S3:</a:t>
            </a:r>
          </a:p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QR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: Interquartile range; GFR: Glomerular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ltration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e; NA: Not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pplicable.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405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53</Words>
  <Application>Microsoft Office PowerPoint</Application>
  <PresentationFormat>Widescreen</PresentationFormat>
  <Paragraphs>99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Arial Black</vt:lpstr>
      <vt:lpstr>Calibri</vt:lpstr>
      <vt:lpstr>Calibri Light</vt:lpstr>
      <vt:lpstr>Times New Roman</vt:lpstr>
      <vt:lpstr>Office Theme</vt:lpstr>
      <vt:lpstr>Prism 8</vt:lpstr>
      <vt:lpstr>Supplementary data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klinikum Duesseldor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</dc:creator>
  <cp:lastModifiedBy>RAC</cp:lastModifiedBy>
  <cp:revision>477</cp:revision>
  <cp:lastPrinted>2023-04-03T06:21:47Z</cp:lastPrinted>
  <dcterms:created xsi:type="dcterms:W3CDTF">2021-11-27T14:14:35Z</dcterms:created>
  <dcterms:modified xsi:type="dcterms:W3CDTF">2023-04-09T09:01:34Z</dcterms:modified>
</cp:coreProperties>
</file>